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50D019-7FF8-4B8A-99CE-81191697AC6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61764B-5638-4C8C-87F4-C9CE876940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9EC943-B25C-4FA4-9ED0-5E084E32AC5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2772F6-673C-43F7-BF0A-9D53966A851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C51811-C46B-4246-86F9-BC4075DEEC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E0A0E9-10FA-41CE-9C36-75DBBAAEBA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98E19E-49B7-4C7E-A644-29230C160E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110737-B3CD-4162-91E8-C3E1286303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175F90-5F4D-476B-A0E0-0400DF9220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CCCAAD-DEC0-47D1-9DE2-71B6A7D570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ED6266-AB06-4A00-A0B0-74AD1CEB82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EA4C7C-9928-45AC-977A-F1DF6ACA4E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A354E49-3D9F-49A9-8AAE-45DA7655584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80880" y="1066680"/>
          <a:ext cx="8458200" cy="4273560"/>
        </p:xfrm>
        <a:graphic>
          <a:graphicData uri="http://schemas.openxmlformats.org/drawingml/2006/table">
            <a:tbl>
              <a:tblPr/>
              <a:tblGrid>
                <a:gridCol w="990720"/>
                <a:gridCol w="685800"/>
                <a:gridCol w="914400"/>
                <a:gridCol w="990720"/>
                <a:gridCol w="1058760"/>
                <a:gridCol w="846000"/>
                <a:gridCol w="838440"/>
                <a:gridCol w="685800"/>
                <a:gridCol w="685800"/>
                <a:gridCol w="761760"/>
              </a:tblGrid>
              <a:tr h="457200">
                <a:tc rowSpan="2"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tfor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mber of genes teste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ample input per reac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mber of replicates per assa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ata normaliz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tection sensitivity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say range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log10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ecision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c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(median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872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6764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oth A &amp; B above LOQ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oth A &amp; B below LOQ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ll dat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≥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00 transcript copi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820800"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T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NA from 9ng total RNA, one RT reaction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x replicates of cDN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rmalized against POLR2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3 (92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 (0 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820800"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aqMan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9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NA from 10ng total RNA, one RT reac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ur replicates of cDN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rmalized against POLR2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57 (86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8 (3.8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4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820440"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a</a:t>
                      </a: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T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PCR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NA from 10ng total RNA, one RT reac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hree replicates of cDN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rmalized against ACT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3 (94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 (2.0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2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8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677880"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QuantiGene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0ng total RN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hree replicates of RN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riginal dat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3 (91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 (2.0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720" rIns="45720" tIns="46800" bIns="46800" anchor="ctr" anchorCtr="1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872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442080" y="569880"/>
            <a:ext cx="8297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omparison of performance metrics among the four quantitative platform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65040" y="189000"/>
            <a:ext cx="1886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dditional fil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36600" y="5518080"/>
            <a:ext cx="865512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 table is modified from Table 1 of the MAQC publication (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Nat Biotechnol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24:1115-22, 2006).  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etection sensitivity: the number (percent in brackets) of genes in both Samples A and B that are above or below the limit of quantitation (LOQ) of each platform. 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 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ssay range: based on the ratio (highest detectable signal/lowest detectable signal) of all genes and samples measured in each platform. 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ecision: based on the median value of CV measured either (1) in all genes and all samples in each platform, or (2) in samples with at least 6000 transcript molecules. 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ata from these platforms are obtained from the MAQC publication (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Nat Biotechnol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24:1115-22, 2006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06T14:45:26Z</dcterms:created>
  <dc:creator> </dc:creator>
  <dc:description/>
  <dc:language>en-US</dc:language>
  <cp:lastModifiedBy> </cp:lastModifiedBy>
  <dcterms:modified xsi:type="dcterms:W3CDTF">2008-07-02T19:36:48Z</dcterms:modified>
  <cp:revision>12</cp:revision>
  <dc:subject/>
  <dc:title>Slide 1</dc:title>
</cp:coreProperties>
</file>